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2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7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7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9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6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318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596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88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206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34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77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57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DDB5FD-266A-476F-995D-D4560597649C}"/>
              </a:ext>
            </a:extLst>
          </p:cNvPr>
          <p:cNvSpPr txBox="1"/>
          <p:nvPr/>
        </p:nvSpPr>
        <p:spPr>
          <a:xfrm>
            <a:off x="1" y="211014"/>
            <a:ext cx="6775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3. Target sequences f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RNA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as9-CRISPR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2C37B6C-C1F5-49FC-BB7D-ECE6E1B67B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5392160"/>
              </p:ext>
            </p:extLst>
          </p:nvPr>
        </p:nvGraphicFramePr>
        <p:xfrm>
          <a:off x="953965" y="644769"/>
          <a:ext cx="4950070" cy="3601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18492">
                  <a:extLst>
                    <a:ext uri="{9D8B030D-6E8A-4147-A177-3AD203B41FA5}">
                      <a16:colId xmlns:a16="http://schemas.microsoft.com/office/drawing/2014/main" val="3755660372"/>
                    </a:ext>
                  </a:extLst>
                </a:gridCol>
                <a:gridCol w="3531578">
                  <a:extLst>
                    <a:ext uri="{9D8B030D-6E8A-4147-A177-3AD203B41FA5}">
                      <a16:colId xmlns:a16="http://schemas.microsoft.com/office/drawing/2014/main" val="256972532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84579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F1A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CTAGAGATGCAGCAAGA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6542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AS1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1: TATGTCCTGTTAGCTCCACCT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2: ATCACTTCAATCTTCAGGTCG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3: TATCATTGGGTACATTTGCGC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4: TTGAAATCCGTCTGGGTACTG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5: TTCTCACGAATCTCCTCATGG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49599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NT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ATAAACCATCTGACTTCTC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1766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FF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12: CGAGGAGGTGACACGGCTCAA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1: AGCTCTAAAGATCAAGCGAGA </a:t>
                      </a:r>
                    </a:p>
                    <a:p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2: CGTGTGCCAGAAGGAGGAGCT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280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H1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TCTTGGGCATTCTTGCTG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2158238"/>
                  </a:ext>
                </a:extLst>
              </a:tr>
              <a:tr h="14341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1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RNA: TGCACAGCTGAGGGACAAATT</a:t>
                      </a: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s9-CRISPR: GACAGCTGTATCTGGCCAC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409042"/>
                  </a:ext>
                </a:extLst>
              </a:tr>
              <a:tr h="14341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3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9-CRISPR: </a:t>
                      </a: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CACTGTAGAGCTGA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10027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5796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55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jung Moon</dc:creator>
  <cp:lastModifiedBy>Moon Ejung</cp:lastModifiedBy>
  <cp:revision>24</cp:revision>
  <cp:lastPrinted>2018-12-27T23:59:30Z</cp:lastPrinted>
  <dcterms:created xsi:type="dcterms:W3CDTF">2018-12-27T23:58:40Z</dcterms:created>
  <dcterms:modified xsi:type="dcterms:W3CDTF">2021-05-20T15:25:48Z</dcterms:modified>
</cp:coreProperties>
</file>